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  <p:sldId id="259" r:id="rId4"/>
    <p:sldId id="263" r:id="rId5"/>
    <p:sldId id="260" r:id="rId6"/>
    <p:sldId id="25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6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FF56938-4251-6A94-E195-8CE45231C5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6922AFA1-7814-FF23-6DC0-ECF6EEBE68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69C40BC-F2B5-95F2-ACB0-4E23E92753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92215-0495-4849-B64E-27CAE8126F73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48B2F50-9091-212D-1605-1D87C145F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A3F2AE7-6AD9-AB49-F694-C7B74311CE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FC5A8-8159-42A3-B005-B551D9080B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9252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C96FF6E-052E-669C-843E-32D3CCFF9C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6771F3D6-7F99-F135-2AD1-013F90E0AD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8278193-65B9-C1EE-9F5A-345C6759DB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92215-0495-4849-B64E-27CAE8126F73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E913591-ECE3-BA8E-2B8F-488A902358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448AF28-20D8-F19A-28A2-EB2C1DFDE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FC5A8-8159-42A3-B005-B551D9080B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2278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E1D6805E-68B0-2060-6515-1719788717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BA09F6F0-7A2F-4CEA-7D80-B57F0E10B3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A288F1D-3357-97C7-B1D1-88934D425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92215-0495-4849-B64E-27CAE8126F73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D9BD377-E28B-5073-0B32-1D7C67C904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A07F522-FC4C-39A4-D239-DFB992455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FC5A8-8159-42A3-B005-B551D9080B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9689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EA10FDA-9FE8-A4BD-73FE-0F424C3860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DAF0280-DCEC-875C-3D2F-62B712C232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F46EE97-6A23-B6FA-D654-1C5BE6160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92215-0495-4849-B64E-27CAE8126F73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8B1EA10-C992-AF3A-8646-EFBB1F7DDC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F05FCCD-C0C5-6563-FC69-0793BA8AC4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FC5A8-8159-42A3-B005-B551D9080B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5100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C763296-1AD7-6A41-668D-F2668980D8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94D196C-184B-A36D-50C4-E92CE83A40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B4BC874-3E1A-0D45-BB8B-AB2051C952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92215-0495-4849-B64E-27CAE8126F73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A6C3D95-7610-271A-DE5A-DB806DB06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D5FA0CC-FC24-B599-863F-13E66759D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FC5A8-8159-42A3-B005-B551D9080B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6400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E77497E-DF3A-F32A-7046-E308AF3E1F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44DD92C-053A-954B-6ECE-5BD6D5E30A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4C24F888-EA28-8183-8F41-913737BEB0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97C0CDB-0D5C-DEF0-2543-E283651EE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92215-0495-4849-B64E-27CAE8126F73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04B60A3-AC87-32D0-3242-8DE4C51C99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9B2DE19-6F8B-8F1A-5F53-84BBE5FD41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FC5A8-8159-42A3-B005-B551D9080B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958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FB112E8-37A1-FD28-DF42-1D29F44322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D3F9274-7D1D-E015-BE8C-2B35EF9363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0294341-4557-A6CC-D023-36A13FCFDF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C2D8F17E-2C0F-FC66-80D8-8EB34B726D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6638761D-F1A7-86E4-27B3-248865B719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68891E7B-A3A6-04C8-8BDF-8B0C25912A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92215-0495-4849-B64E-27CAE8126F73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B53452EF-1553-7642-96B0-2BA3E22B00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2C537B4E-93BF-2FA8-48CA-4C14127AB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FC5A8-8159-42A3-B005-B551D9080B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664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202A646-172E-83B4-8AFA-64CBBFBC86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97AF19D8-1D5E-9653-6721-3ACB625E9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92215-0495-4849-B64E-27CAE8126F73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27E09A46-DDC2-BAF0-9A92-6E94EE1A7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00B4181D-0237-9E9E-E97B-604C1BE171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FC5A8-8159-42A3-B005-B551D9080B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7212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B02A3AEE-672B-5836-697C-090B17F04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92215-0495-4849-B64E-27CAE8126F73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611D54E-CA3A-EB74-EB90-4415FCC4AC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6DD63019-423D-D2C8-9D4A-684C9AAE8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FC5A8-8159-42A3-B005-B551D9080B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5981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D1D35D8-B97A-56B1-5268-FD0E391295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BA7AB7A-3157-1455-998B-E8B5F05010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DC5175BC-E27E-0003-AA7E-981B90BD87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8E622A7-D6F9-9177-101D-95ED9A99B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92215-0495-4849-B64E-27CAE8126F73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30E6544-49B3-9697-4E9C-F9B331772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9B9B6B8-1372-0BF8-BF0D-5B10DF49A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FC5A8-8159-42A3-B005-B551D9080B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060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90CBAC5-9E1C-4BBD-4EF8-2C74E19528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CC802379-81D5-B102-95BC-C1838DBEDF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3B396687-DE65-8867-0621-7E69BA6E23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A4DACA7-8A02-CD1F-772D-5161914268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92215-0495-4849-B64E-27CAE8126F73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A48E577-4034-B856-437A-3BCE58B992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5A6C6C1-80A1-19B4-FFA8-C014E183E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FC5A8-8159-42A3-B005-B551D9080B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701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E0B03108-F40C-6EF4-ED4F-363AF35D62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D54767F-BEEA-13C1-412F-84874DA368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89DF1A8-0AF5-10AB-3CF4-32808C7D58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B92215-0495-4849-B64E-27CAE8126F73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0172040-EF43-F59A-FF55-61F8980D7A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B7E671E-1E16-6787-E0E7-90BA479FD2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4FC5A8-8159-42A3-B005-B551D9080B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2044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microsoft.com/office/2007/relationships/media" Target="../media/media1.mp4"/><Relationship Id="rId1" Type="http://schemas.openxmlformats.org/officeDocument/2006/relationships/video" Target="NULL" TargetMode="External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microsoft.com/office/2007/relationships/media" Target="../media/media2.mp4"/><Relationship Id="rId1" Type="http://schemas.openxmlformats.org/officeDocument/2006/relationships/video" Target="NULL" TargetMode="Externa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microsoft.com/office/2007/relationships/media" Target="../media/media3.mp4"/><Relationship Id="rId1" Type="http://schemas.openxmlformats.org/officeDocument/2006/relationships/video" Target="NULL" TargetMode="External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microsoft.com/office/2007/relationships/media" Target="../media/media4.mp4"/><Relationship Id="rId1" Type="http://schemas.openxmlformats.org/officeDocument/2006/relationships/video" Target="NULL" TargetMode="External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microsoft.com/office/2007/relationships/media" Target="../media/media5.mp4"/><Relationship Id="rId1" Type="http://schemas.openxmlformats.org/officeDocument/2006/relationships/video" Target="NULL" TargetMode="External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microsoft.com/office/2007/relationships/media" Target="../media/media6.mp4"/><Relationship Id="rId1" Type="http://schemas.openxmlformats.org/officeDocument/2006/relationships/video" Target="NULL" TargetMode="Externa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635192E-48FF-964A-B788-980F593C91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GB" dirty="0"/>
              <a:t>Additional file 1: Video </a:t>
            </a:r>
            <a:r>
              <a:rPr lang="en-GB" dirty="0" smtClean="0"/>
              <a:t>S1</a:t>
            </a:r>
            <a:endParaRPr lang="en-GB" dirty="0"/>
          </a:p>
        </p:txBody>
      </p:sp>
      <p:pic>
        <p:nvPicPr>
          <p:cNvPr id="9" name="0000913850_US-20250715_0_20250715_135119_0011">
            <a:hlinkClick r:id="" action="ppaction://media"/>
            <a:extLst>
              <a:ext uri="{FF2B5EF4-FFF2-40B4-BE49-F238E27FC236}">
                <a16:creationId xmlns:a16="http://schemas.microsoft.com/office/drawing/2014/main" xmlns="" id="{74BA9FB6-5192-44C2-597B-9E8C9288AED7}"/>
              </a:ext>
            </a:extLst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r:embed="rId2">
                  <p14:trim end="1166.625"/>
                </p14:media>
              </p:ext>
            </p:extLst>
          </p:nvPr>
        </p:nvPicPr>
        <p:blipFill>
          <a:blip r:embed="rId4"/>
          <a:srcRect l="29011" r="236" b="25253"/>
          <a:stretch>
            <a:fillRect/>
          </a:stretch>
        </p:blipFill>
        <p:spPr>
          <a:xfrm>
            <a:off x="3236728" y="1690688"/>
            <a:ext cx="5718544" cy="4529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69138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8EEC0A1-A9ED-5A79-3F42-ECC7F98581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GB" dirty="0" smtClean="0"/>
              <a:t>Video S2</a:t>
            </a:r>
            <a:endParaRPr lang="en-GB" dirty="0"/>
          </a:p>
        </p:txBody>
      </p:sp>
      <p:pic>
        <p:nvPicPr>
          <p:cNvPr id="4" name="0000913850_US-20250715_0_20250715_135203_0012">
            <a:hlinkClick r:id="" action="ppaction://media"/>
            <a:extLst>
              <a:ext uri="{FF2B5EF4-FFF2-40B4-BE49-F238E27FC236}">
                <a16:creationId xmlns:a16="http://schemas.microsoft.com/office/drawing/2014/main" xmlns="" id="{6330FCBD-7740-C5F3-1F54-76A0BE95211A}"/>
              </a:ext>
            </a:extLst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r:embed="rId2">
                  <p14:trim end="1166.625"/>
                </p14:media>
              </p:ext>
            </p:extLst>
          </p:nvPr>
        </p:nvPicPr>
        <p:blipFill>
          <a:blip r:embed="rId4"/>
          <a:srcRect l="29743" b="25777"/>
          <a:stretch>
            <a:fillRect/>
          </a:stretch>
        </p:blipFill>
        <p:spPr>
          <a:xfrm>
            <a:off x="3233680" y="1690688"/>
            <a:ext cx="5724640" cy="4529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58826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81D63EB-6B5E-E643-7971-756387E610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GB" dirty="0" smtClean="0"/>
              <a:t>Video S3</a:t>
            </a:r>
            <a:endParaRPr lang="en-GB" dirty="0"/>
          </a:p>
        </p:txBody>
      </p:sp>
      <p:pic>
        <p:nvPicPr>
          <p:cNvPr id="11" name="0000913850_US-20250715_0_20250715_135624_0019">
            <a:hlinkClick r:id="" action="ppaction://media"/>
            <a:extLst>
              <a:ext uri="{FF2B5EF4-FFF2-40B4-BE49-F238E27FC236}">
                <a16:creationId xmlns:a16="http://schemas.microsoft.com/office/drawing/2014/main" xmlns="" id="{87D41471-47BD-FD27-0C3E-A323605C2082}"/>
              </a:ext>
            </a:extLst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r:embed="rId2">
                  <p14:trim st="1000" end="166.625"/>
                </p14:media>
              </p:ext>
            </p:extLst>
          </p:nvPr>
        </p:nvPicPr>
        <p:blipFill>
          <a:blip r:embed="rId4"/>
          <a:srcRect l="29198" b="25106"/>
          <a:stretch>
            <a:fillRect/>
          </a:stretch>
        </p:blipFill>
        <p:spPr>
          <a:xfrm>
            <a:off x="3230632" y="1690688"/>
            <a:ext cx="5730736" cy="4535817"/>
          </a:xfrm>
        </p:spPr>
      </p:pic>
    </p:spTree>
    <p:extLst>
      <p:ext uri="{BB962C8B-B14F-4D97-AF65-F5344CB8AC3E}">
        <p14:creationId xmlns:p14="http://schemas.microsoft.com/office/powerpoint/2010/main" val="384876160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0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D3C75CD-D4A3-F358-8455-6C3A04963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GB" dirty="0" smtClean="0"/>
              <a:t>Video S4</a:t>
            </a:r>
            <a:endParaRPr lang="en-GB" dirty="0"/>
          </a:p>
        </p:txBody>
      </p:sp>
      <p:pic>
        <p:nvPicPr>
          <p:cNvPr id="11" name="0000913850_US-20250715_0_20250715_135611_0018">
            <a:hlinkClick r:id="" action="ppaction://media"/>
            <a:extLst>
              <a:ext uri="{FF2B5EF4-FFF2-40B4-BE49-F238E27FC236}">
                <a16:creationId xmlns:a16="http://schemas.microsoft.com/office/drawing/2014/main" xmlns="" id="{758D7475-BFB2-29DF-E04C-2B64C60C73EC}"/>
              </a:ext>
            </a:extLst>
          </p:cNvPr>
          <p:cNvPicPr>
            <a:picLocks noGrp="1" noChangeAspect="1"/>
          </p:cNvPicPr>
          <p:nvPr>
            <p:ph idx="1"/>
            <a:videoFile r:link="rId1"/>
            <p:extLst>
              <p:ext uri="{DAA4B4D4-6D71-4841-9C94-3DE7FCFB9230}">
                <p14:media xmlns:p14="http://schemas.microsoft.com/office/powerpoint/2010/main" r:embed="rId2">
                  <p14:trim st="1166" end="0.625"/>
                </p14:media>
              </p:ext>
            </p:extLst>
          </p:nvPr>
        </p:nvPicPr>
        <p:blipFill>
          <a:blip r:embed="rId4"/>
          <a:srcRect l="29034" r="475" b="25537"/>
          <a:stretch>
            <a:fillRect/>
          </a:stretch>
        </p:blipFill>
        <p:spPr>
          <a:xfrm>
            <a:off x="3227583" y="1690688"/>
            <a:ext cx="5736833" cy="45358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946751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0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DCD0148-5656-A813-F5BD-64CFE416EE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GB" dirty="0" smtClean="0"/>
              <a:t>Video S5</a:t>
            </a:r>
            <a:endParaRPr lang="en-GB" dirty="0"/>
          </a:p>
        </p:txBody>
      </p:sp>
      <p:pic>
        <p:nvPicPr>
          <p:cNvPr id="7" name="0000913850_US-20250715_0_20250715_135458_0017">
            <a:hlinkClick r:id="" action="ppaction://media"/>
            <a:extLst>
              <a:ext uri="{FF2B5EF4-FFF2-40B4-BE49-F238E27FC236}">
                <a16:creationId xmlns:a16="http://schemas.microsoft.com/office/drawing/2014/main" xmlns="" id="{0D714E89-1251-663B-3A6D-C9DF4B1019A5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>
                  <p14:trim end="1166.625"/>
                </p14:media>
              </p:ext>
            </p:extLst>
          </p:nvPr>
        </p:nvPicPr>
        <p:blipFill>
          <a:blip r:embed="rId4"/>
          <a:srcRect l="28289" r="114" b="24264"/>
          <a:stretch>
            <a:fillRect/>
          </a:stretch>
        </p:blipFill>
        <p:spPr>
          <a:xfrm>
            <a:off x="3232875" y="1690688"/>
            <a:ext cx="5726250" cy="45291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360711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7257914-A094-38F6-A436-77F48D2A27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GB" dirty="0" smtClean="0"/>
              <a:t>Video S6</a:t>
            </a:r>
            <a:endParaRPr lang="en-GB" dirty="0"/>
          </a:p>
        </p:txBody>
      </p:sp>
      <p:pic>
        <p:nvPicPr>
          <p:cNvPr id="9" name="0000913850_US-20250715_0_20250715_135431_0016">
            <a:hlinkClick r:id="" action="ppaction://media"/>
            <a:extLst>
              <a:ext uri="{FF2B5EF4-FFF2-40B4-BE49-F238E27FC236}">
                <a16:creationId xmlns:a16="http://schemas.microsoft.com/office/drawing/2014/main" xmlns="" id="{F0C2E05A-6112-88B8-3CE1-BBAA3A5448B7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>
                  <p14:trim st="1166"/>
                </p14:media>
              </p:ext>
            </p:extLst>
          </p:nvPr>
        </p:nvPicPr>
        <p:blipFill>
          <a:blip r:embed="rId4"/>
          <a:srcRect l="27549" r="-128" b="23220"/>
          <a:stretch>
            <a:fillRect/>
          </a:stretch>
        </p:blipFill>
        <p:spPr>
          <a:xfrm>
            <a:off x="3238166" y="1690688"/>
            <a:ext cx="5715667" cy="45291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78485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16</Words>
  <Application>Microsoft Office PowerPoint</Application>
  <PresentationFormat>Widescreen</PresentationFormat>
  <Paragraphs>6</Paragraphs>
  <Slides>6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Additional file 1: Video S1</vt:lpstr>
      <vt:lpstr>Video S2</vt:lpstr>
      <vt:lpstr>Video S3</vt:lpstr>
      <vt:lpstr>Video S4</vt:lpstr>
      <vt:lpstr>Video S5</vt:lpstr>
      <vt:lpstr>Video S6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file 1: Video S1</dc:title>
  <dc:creator>Yuki Munekata</dc:creator>
  <cp:lastModifiedBy>Aarthi K Krishnamoorthy P</cp:lastModifiedBy>
  <cp:revision>23</cp:revision>
  <dcterms:created xsi:type="dcterms:W3CDTF">2025-07-19T03:14:25Z</dcterms:created>
  <dcterms:modified xsi:type="dcterms:W3CDTF">2025-10-03T06:54:20Z</dcterms:modified>
</cp:coreProperties>
</file>